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8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CB5EE5-804E-40CF-98DC-73796E73B3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1C866CF-4955-4641-B33D-09B896C363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5D2D739-AB08-43A5-8BCC-406183BB8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E4B52B5-F089-4912-998D-89C0B3DF6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A97452-7E5A-4D21-887A-16091DBEA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31098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0786A6-F6B4-4977-AD53-5863F28D04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7AA125-2472-4BB3-909A-C4852106C6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F317807-4842-473E-A50B-4BDD3C938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A86A582-2C6D-4F4D-A8C2-3DF904238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0BC2E15-02DA-49BF-A1E4-15FAD287E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69486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CA8848E-E4BE-4B32-9F17-FD0C70846F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74F1FE7-3FB0-482A-BBDB-0F5B43C0D3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A9713B8-C9FE-4FF6-8707-6430430C4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3F9AAB-69EE-4F7B-B56A-F049DEBFF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6F1D483-5D34-4039-A27F-233A6CD97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59960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1FA1ED-2688-49E6-9733-134664723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66B1133-44DB-45C5-8D64-38A9B558AA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79258D0-2201-4654-9E54-E2584B9C5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60CD9FF-091C-4969-A7D4-C93A82A1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AF377DE-A709-439A-B730-B40A7F1E8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70190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953F46-2C23-4A80-B1E8-7948A9700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3860326-6F0E-41D0-9C23-4DF5A107CB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F688891-D017-4206-92F0-FCC892C60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E73B987-4636-4E4F-9C94-0B291901B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DD9B507-F3FE-40CB-912C-54B6A5897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67790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7B704E-6A04-4481-A15E-BDEA9F3E0D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F93EEA9-4629-4D29-BB14-4902DEA839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8AD2F2B-9EDA-467A-ACE3-2F5E5CBF0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3700395-97AE-4E89-9750-BC1F30EB4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59E4F8D-0504-4C80-8FC0-5DC429887B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ABF9A7F-431F-4EF8-A214-A512F3E9F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68619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A561D3-154B-434B-B643-4BF17008A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3AC117B-FBC3-4840-B998-D329609F4C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8F664BE-C314-43E9-9F31-07721534D0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1CB00FA-8227-49B5-BAE8-AFB1F03BB8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A305D149-9D80-44DF-A6C7-8BCC294E8E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0370C22-E9F8-49A3-81C9-B9AA226EB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5127D7A-340A-47A9-A16B-462BDF199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F527ADA-F0A1-459B-B6BB-B537B16A0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58683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178B98-713E-412F-959D-0FC09F75E9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B80E5E8-C217-4A85-B0C0-AAE76D77D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C8D97BA-F891-4D98-B1A2-14BB31592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9FD6ACA-9624-42E5-A518-63E951739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37961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985232C-2985-4C85-A814-62C2CB7D6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ACE4E5F-22F6-4245-A395-AC7A46B6D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ADDDAB3-7748-4B2B-901D-300CB3CAF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4962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8829065-6F1E-4313-8044-51F24428EF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82D031E-0D45-4708-92D3-7E8509522A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7C3B68C-06CF-466A-A252-77F1B17D61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73024F8-CD7A-45F0-B48F-A56EEE00B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8BEE972-4ED9-4DE4-9239-7DEBDB779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CA46009-96F4-49B0-A765-A2B61E5FA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43503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59249D-A930-4412-8777-BDCA4FB2EB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AED6E1F-8FE7-4E1D-AC86-B09465C2F6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E6421ED-5751-4CD6-B7D8-B1232B158E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CB1DB6A-4C7E-40E8-B729-FC2585C5A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8CBD9CF-61F3-4939-A6B9-D18DE91C2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A3B181E-6C02-4699-80D8-C338BD3E7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33077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BB95689-E537-4013-B9AB-A87A541A7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F46E67A-A7BF-4F96-BF61-BA1667AD30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4FD5E22-429F-432A-84C1-57C8175B42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DD383-73F6-48A1-B3D4-48EA99348F31}" type="datetimeFigureOut">
              <a:rPr lang="es-MX" smtClean="0"/>
              <a:t>26/05/2021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C3A2FB3-F01A-4276-8C08-4E6FB516DB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36F40D7-90C0-4BA8-834E-50CC414717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F9784-C276-4EC6-9223-70843DAA391B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80228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0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g"/><Relationship Id="rId5" Type="http://schemas.openxmlformats.org/officeDocument/2006/relationships/image" Target="../media/image3.jpg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CuadroTexto 28">
            <a:extLst>
              <a:ext uri="{FF2B5EF4-FFF2-40B4-BE49-F238E27FC236}">
                <a16:creationId xmlns:a16="http://schemas.microsoft.com/office/drawing/2014/main" id="{9E3BF491-6227-4495-B7F2-CC0450D734D5}"/>
              </a:ext>
            </a:extLst>
          </p:cNvPr>
          <p:cNvSpPr txBox="1"/>
          <p:nvPr/>
        </p:nvSpPr>
        <p:spPr>
          <a:xfrm>
            <a:off x="6627007" y="1926292"/>
            <a:ext cx="35253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12               52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3C958BF6-2F6C-4960-8DA3-66F239463ED7}"/>
              </a:ext>
            </a:extLst>
          </p:cNvPr>
          <p:cNvSpPr txBox="1"/>
          <p:nvPr/>
        </p:nvSpPr>
        <p:spPr>
          <a:xfrm>
            <a:off x="6609511" y="1232469"/>
            <a:ext cx="3538148" cy="1158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IRE1</a:t>
            </a:r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107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2F877868-31EA-41B4-AAAB-992D593A3EF1}"/>
              </a:ext>
            </a:extLst>
          </p:cNvPr>
          <p:cNvSpPr txBox="1"/>
          <p:nvPr/>
        </p:nvSpPr>
        <p:spPr>
          <a:xfrm>
            <a:off x="6650711" y="2337048"/>
            <a:ext cx="34900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XBP1                         30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65A3EB15-D261-4BF0-ABEA-1FB4B30794D8}"/>
              </a:ext>
            </a:extLst>
          </p:cNvPr>
          <p:cNvSpPr txBox="1"/>
          <p:nvPr/>
        </p:nvSpPr>
        <p:spPr>
          <a:xfrm>
            <a:off x="6649449" y="3502474"/>
            <a:ext cx="35012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43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B5EDA07-D937-4E08-B21B-B4D636D3F368}"/>
              </a:ext>
            </a:extLst>
          </p:cNvPr>
          <p:cNvSpPr txBox="1"/>
          <p:nvPr/>
        </p:nvSpPr>
        <p:spPr>
          <a:xfrm>
            <a:off x="6664837" y="3067252"/>
            <a:ext cx="35012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Bax                            24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D6C4A9A3-42D9-44C0-B0CE-CD993DF9DC3B}"/>
              </a:ext>
            </a:extLst>
          </p:cNvPr>
          <p:cNvSpPr txBox="1"/>
          <p:nvPr/>
        </p:nvSpPr>
        <p:spPr>
          <a:xfrm>
            <a:off x="6650323" y="2662780"/>
            <a:ext cx="35012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Bcl2                           29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A4FA352C-1512-4F33-B46B-EC2C7E629DF9}"/>
              </a:ext>
            </a:extLst>
          </p:cNvPr>
          <p:cNvSpPr txBox="1"/>
          <p:nvPr/>
        </p:nvSpPr>
        <p:spPr>
          <a:xfrm>
            <a:off x="6655851" y="1565002"/>
            <a:ext cx="34435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p53                            53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5B1D1BC8-9CB6-464C-9D11-0F67732844DD}"/>
              </a:ext>
            </a:extLst>
          </p:cNvPr>
          <p:cNvSpPr txBox="1"/>
          <p:nvPr/>
        </p:nvSpPr>
        <p:spPr>
          <a:xfrm>
            <a:off x="1089912" y="767655"/>
            <a:ext cx="1141659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Euthyroid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FD6CC5F7-EC83-411A-B862-8FB4E86DADB5}"/>
              </a:ext>
            </a:extLst>
          </p:cNvPr>
          <p:cNvSpPr txBox="1"/>
          <p:nvPr/>
        </p:nvSpPr>
        <p:spPr>
          <a:xfrm>
            <a:off x="2329546" y="771288"/>
            <a:ext cx="1391728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ypothyroid</a:t>
            </a:r>
            <a:endParaRPr lang="es-MX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25E9F7A7-43A0-48FB-A716-50900D8BA3CA}"/>
              </a:ext>
            </a:extLst>
          </p:cNvPr>
          <p:cNvCxnSpPr>
            <a:cxnSpLocks/>
          </p:cNvCxnSpPr>
          <p:nvPr/>
        </p:nvCxnSpPr>
        <p:spPr>
          <a:xfrm>
            <a:off x="1147968" y="1135084"/>
            <a:ext cx="1022252" cy="8471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recto 42">
            <a:extLst>
              <a:ext uri="{FF2B5EF4-FFF2-40B4-BE49-F238E27FC236}">
                <a16:creationId xmlns:a16="http://schemas.microsoft.com/office/drawing/2014/main" id="{63B3B73E-743B-415E-A600-7DA341405A1C}"/>
              </a:ext>
            </a:extLst>
          </p:cNvPr>
          <p:cNvCxnSpPr>
            <a:cxnSpLocks/>
          </p:cNvCxnSpPr>
          <p:nvPr/>
        </p:nvCxnSpPr>
        <p:spPr>
          <a:xfrm>
            <a:off x="2489202" y="1143170"/>
            <a:ext cx="1059652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ector recto 45">
            <a:extLst>
              <a:ext uri="{FF2B5EF4-FFF2-40B4-BE49-F238E27FC236}">
                <a16:creationId xmlns:a16="http://schemas.microsoft.com/office/drawing/2014/main" id="{A2951F28-8DC8-4AB4-A1D0-6466878C7BA9}"/>
              </a:ext>
            </a:extLst>
          </p:cNvPr>
          <p:cNvCxnSpPr>
            <a:cxnSpLocks/>
          </p:cNvCxnSpPr>
          <p:nvPr/>
        </p:nvCxnSpPr>
        <p:spPr>
          <a:xfrm>
            <a:off x="3882846" y="1149983"/>
            <a:ext cx="111141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id="{CDF0857F-044E-4D23-B10C-248968613371}"/>
              </a:ext>
            </a:extLst>
          </p:cNvPr>
          <p:cNvCxnSpPr>
            <a:cxnSpLocks/>
          </p:cNvCxnSpPr>
          <p:nvPr/>
        </p:nvCxnSpPr>
        <p:spPr>
          <a:xfrm>
            <a:off x="5310776" y="1135469"/>
            <a:ext cx="119770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47B2FACA-0250-47DE-86B3-949C9D437B14}"/>
              </a:ext>
            </a:extLst>
          </p:cNvPr>
          <p:cNvCxnSpPr>
            <a:cxnSpLocks/>
          </p:cNvCxnSpPr>
          <p:nvPr/>
        </p:nvCxnSpPr>
        <p:spPr>
          <a:xfrm>
            <a:off x="1563016" y="721190"/>
            <a:ext cx="1586584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57">
            <a:extLst>
              <a:ext uri="{FF2B5EF4-FFF2-40B4-BE49-F238E27FC236}">
                <a16:creationId xmlns:a16="http://schemas.microsoft.com/office/drawing/2014/main" id="{EAD5C9D0-E9A9-4051-9E16-4C54AE4B3852}"/>
              </a:ext>
            </a:extLst>
          </p:cNvPr>
          <p:cNvCxnSpPr>
            <a:cxnSpLocks/>
          </p:cNvCxnSpPr>
          <p:nvPr/>
        </p:nvCxnSpPr>
        <p:spPr>
          <a:xfrm>
            <a:off x="4429258" y="778226"/>
            <a:ext cx="152160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CuadroTexto 60">
            <a:extLst>
              <a:ext uri="{FF2B5EF4-FFF2-40B4-BE49-F238E27FC236}">
                <a16:creationId xmlns:a16="http://schemas.microsoft.com/office/drawing/2014/main" id="{152DD7AD-D14C-433D-9BED-18C34D5A0C7B}"/>
              </a:ext>
            </a:extLst>
          </p:cNvPr>
          <p:cNvSpPr txBox="1"/>
          <p:nvPr/>
        </p:nvSpPr>
        <p:spPr>
          <a:xfrm>
            <a:off x="4476872" y="375199"/>
            <a:ext cx="1463862" cy="4401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Gallic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C78D0A00-2BDF-4488-B0FA-C650E1D68B4A}"/>
              </a:ext>
            </a:extLst>
          </p:cNvPr>
          <p:cNvSpPr txBox="1"/>
          <p:nvPr/>
        </p:nvSpPr>
        <p:spPr>
          <a:xfrm>
            <a:off x="1834327" y="330955"/>
            <a:ext cx="1068178" cy="4401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C98A6A36-F7C2-499B-85DC-1D2B51B2A0F2}"/>
              </a:ext>
            </a:extLst>
          </p:cNvPr>
          <p:cNvSpPr txBox="1"/>
          <p:nvPr/>
        </p:nvSpPr>
        <p:spPr>
          <a:xfrm>
            <a:off x="3869402" y="789424"/>
            <a:ext cx="1141659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Euthyroid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2C259917-6FBD-4055-8EBA-9DD1541D663C}"/>
              </a:ext>
            </a:extLst>
          </p:cNvPr>
          <p:cNvSpPr txBox="1"/>
          <p:nvPr/>
        </p:nvSpPr>
        <p:spPr>
          <a:xfrm>
            <a:off x="5210634" y="793057"/>
            <a:ext cx="1391728" cy="3724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ypothyroid</a:t>
            </a:r>
            <a:endParaRPr lang="es-MX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Imagen 27">
            <a:extLst>
              <a:ext uri="{FF2B5EF4-FFF2-40B4-BE49-F238E27FC236}">
                <a16:creationId xmlns:a16="http://schemas.microsoft.com/office/drawing/2014/main" id="{475607B9-4B40-4847-A1F2-473967738E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854" y="3560078"/>
            <a:ext cx="5726475" cy="400110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2D09B356-1991-4947-BE45-DF1E0F9FA3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06" t="-2356" r="-352" b="34827"/>
          <a:stretch/>
        </p:blipFill>
        <p:spPr>
          <a:xfrm>
            <a:off x="940854" y="1299288"/>
            <a:ext cx="5756721" cy="221508"/>
          </a:xfrm>
          <a:prstGeom prst="rect">
            <a:avLst/>
          </a:prstGeom>
        </p:spPr>
      </p:pic>
      <p:pic>
        <p:nvPicPr>
          <p:cNvPr id="45" name="Imagen 44">
            <a:extLst>
              <a:ext uri="{FF2B5EF4-FFF2-40B4-BE49-F238E27FC236}">
                <a16:creationId xmlns:a16="http://schemas.microsoft.com/office/drawing/2014/main" id="{5178C15B-7D18-48D4-B9CF-19B499E9ADC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7" t="38979" r="-437" b="7401"/>
          <a:stretch/>
        </p:blipFill>
        <p:spPr>
          <a:xfrm>
            <a:off x="1018009" y="2428589"/>
            <a:ext cx="5608998" cy="203658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C864DBB1-A62A-40A4-A054-A84DEEE7B91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1748" y="3098744"/>
            <a:ext cx="5717701" cy="400110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A46900A7-9999-41B8-87D7-E78253E1DBF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765" y="2693445"/>
            <a:ext cx="5705683" cy="342138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956848BD-2AE3-4526-B4CC-1551C7461C9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36272"/>
          <a:stretch/>
        </p:blipFill>
        <p:spPr>
          <a:xfrm>
            <a:off x="969882" y="1607363"/>
            <a:ext cx="5679566" cy="302186"/>
          </a:xfrm>
          <a:prstGeom prst="rect">
            <a:avLst/>
          </a:prstGeom>
        </p:spPr>
      </p:pic>
      <p:pic>
        <p:nvPicPr>
          <p:cNvPr id="11" name="Imagen 10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7E2A46C-80EE-45B8-96F5-7B7C83D1966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448" r="1436"/>
          <a:stretch/>
        </p:blipFill>
        <p:spPr>
          <a:xfrm>
            <a:off x="931747" y="1981757"/>
            <a:ext cx="5717701" cy="342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12754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uadroTexto 12">
            <a:extLst>
              <a:ext uri="{FF2B5EF4-FFF2-40B4-BE49-F238E27FC236}">
                <a16:creationId xmlns:a16="http://schemas.microsoft.com/office/drawing/2014/main" id="{E730C414-00E8-4EB1-8585-FD8BF700B2C2}"/>
              </a:ext>
            </a:extLst>
          </p:cNvPr>
          <p:cNvSpPr txBox="1"/>
          <p:nvPr/>
        </p:nvSpPr>
        <p:spPr>
          <a:xfrm>
            <a:off x="7076265" y="3264100"/>
            <a:ext cx="32976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GADD153               30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A08D7281-BE8F-41F2-A406-DA04A46093B3}"/>
              </a:ext>
            </a:extLst>
          </p:cNvPr>
          <p:cNvSpPr txBox="1"/>
          <p:nvPr/>
        </p:nvSpPr>
        <p:spPr>
          <a:xfrm>
            <a:off x="7099528" y="1823822"/>
            <a:ext cx="3366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GADD34                74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E7F4142-EC26-4BC7-AFA4-56468F1B689D}"/>
              </a:ext>
            </a:extLst>
          </p:cNvPr>
          <p:cNvSpPr txBox="1"/>
          <p:nvPr/>
        </p:nvSpPr>
        <p:spPr>
          <a:xfrm>
            <a:off x="7095413" y="2579576"/>
            <a:ext cx="32640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p-eIF2</a:t>
            </a:r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(Ser 52)    37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2E0DD726-1800-47B8-BEBC-7B122F2E7EED}"/>
              </a:ext>
            </a:extLst>
          </p:cNvPr>
          <p:cNvSpPr txBox="1"/>
          <p:nvPr/>
        </p:nvSpPr>
        <p:spPr>
          <a:xfrm>
            <a:off x="7111397" y="2216327"/>
            <a:ext cx="32305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ATF4                      42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65A3EB15-D261-4BF0-ABEA-1FB4B30794D8}"/>
              </a:ext>
            </a:extLst>
          </p:cNvPr>
          <p:cNvSpPr txBox="1"/>
          <p:nvPr/>
        </p:nvSpPr>
        <p:spPr>
          <a:xfrm>
            <a:off x="7076939" y="3633707"/>
            <a:ext cx="32896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43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7525CA74-EDC4-402D-B97B-9FF503EA3761}"/>
              </a:ext>
            </a:extLst>
          </p:cNvPr>
          <p:cNvSpPr txBox="1"/>
          <p:nvPr/>
        </p:nvSpPr>
        <p:spPr>
          <a:xfrm>
            <a:off x="1423741" y="552349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Euthyroid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947D9A1D-EF1A-494E-A4F7-84FD7E6EEBFC}"/>
              </a:ext>
            </a:extLst>
          </p:cNvPr>
          <p:cNvSpPr txBox="1"/>
          <p:nvPr/>
        </p:nvSpPr>
        <p:spPr>
          <a:xfrm>
            <a:off x="2747599" y="555982"/>
            <a:ext cx="1391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ypothyroid</a:t>
            </a:r>
            <a:endParaRPr lang="es-MX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id="{F8AED01C-5824-43AF-B518-8B81401C8AE7}"/>
              </a:ext>
            </a:extLst>
          </p:cNvPr>
          <p:cNvCxnSpPr>
            <a:cxnSpLocks/>
          </p:cNvCxnSpPr>
          <p:nvPr/>
        </p:nvCxnSpPr>
        <p:spPr>
          <a:xfrm>
            <a:off x="1481797" y="903236"/>
            <a:ext cx="1022252" cy="7701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id="{56D463DE-B411-4748-8717-02C014A3AC24}"/>
              </a:ext>
            </a:extLst>
          </p:cNvPr>
          <p:cNvCxnSpPr>
            <a:cxnSpLocks/>
          </p:cNvCxnSpPr>
          <p:nvPr/>
        </p:nvCxnSpPr>
        <p:spPr>
          <a:xfrm>
            <a:off x="2883191" y="910937"/>
            <a:ext cx="1059652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ctor recto 53">
            <a:extLst>
              <a:ext uri="{FF2B5EF4-FFF2-40B4-BE49-F238E27FC236}">
                <a16:creationId xmlns:a16="http://schemas.microsoft.com/office/drawing/2014/main" id="{CCA75C34-E844-4794-8E38-895E450C94B1}"/>
              </a:ext>
            </a:extLst>
          </p:cNvPr>
          <p:cNvCxnSpPr>
            <a:cxnSpLocks/>
          </p:cNvCxnSpPr>
          <p:nvPr/>
        </p:nvCxnSpPr>
        <p:spPr>
          <a:xfrm>
            <a:off x="4332787" y="917750"/>
            <a:ext cx="111141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ector recto 54">
            <a:extLst>
              <a:ext uri="{FF2B5EF4-FFF2-40B4-BE49-F238E27FC236}">
                <a16:creationId xmlns:a16="http://schemas.microsoft.com/office/drawing/2014/main" id="{9EE6F6CC-99B0-4B19-820F-1047ECBC6A1A}"/>
              </a:ext>
            </a:extLst>
          </p:cNvPr>
          <p:cNvCxnSpPr>
            <a:cxnSpLocks/>
          </p:cNvCxnSpPr>
          <p:nvPr/>
        </p:nvCxnSpPr>
        <p:spPr>
          <a:xfrm>
            <a:off x="5760717" y="903236"/>
            <a:ext cx="119770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EC135150-AB37-4FF6-8053-7EF314EAAA76}"/>
              </a:ext>
            </a:extLst>
          </p:cNvPr>
          <p:cNvCxnSpPr>
            <a:cxnSpLocks/>
          </p:cNvCxnSpPr>
          <p:nvPr/>
        </p:nvCxnSpPr>
        <p:spPr>
          <a:xfrm>
            <a:off x="1896845" y="488957"/>
            <a:ext cx="1586584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5CD6A602-354F-4184-BF83-7A8E108B15C4}"/>
              </a:ext>
            </a:extLst>
          </p:cNvPr>
          <p:cNvCxnSpPr>
            <a:cxnSpLocks/>
          </p:cNvCxnSpPr>
          <p:nvPr/>
        </p:nvCxnSpPr>
        <p:spPr>
          <a:xfrm>
            <a:off x="4879199" y="545993"/>
            <a:ext cx="1521600" cy="0"/>
          </a:xfrm>
          <a:prstGeom prst="line">
            <a:avLst/>
          </a:prstGeom>
          <a:ln w="444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uadroTexto 58">
            <a:extLst>
              <a:ext uri="{FF2B5EF4-FFF2-40B4-BE49-F238E27FC236}">
                <a16:creationId xmlns:a16="http://schemas.microsoft.com/office/drawing/2014/main" id="{F5562497-47B3-4023-877A-734DC1B40D74}"/>
              </a:ext>
            </a:extLst>
          </p:cNvPr>
          <p:cNvSpPr txBox="1"/>
          <p:nvPr/>
        </p:nvSpPr>
        <p:spPr>
          <a:xfrm>
            <a:off x="4926813" y="162971"/>
            <a:ext cx="14638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Gallic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5DF6462C-B76C-45E4-9B77-6CA328EEFFAA}"/>
              </a:ext>
            </a:extLst>
          </p:cNvPr>
          <p:cNvSpPr txBox="1"/>
          <p:nvPr/>
        </p:nvSpPr>
        <p:spPr>
          <a:xfrm>
            <a:off x="2168156" y="118727"/>
            <a:ext cx="10681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60147AAB-5910-43D4-B1BB-1167A6A82FCF}"/>
              </a:ext>
            </a:extLst>
          </p:cNvPr>
          <p:cNvSpPr txBox="1"/>
          <p:nvPr/>
        </p:nvSpPr>
        <p:spPr>
          <a:xfrm>
            <a:off x="7086557" y="2899815"/>
            <a:ext cx="32816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eIF2</a:t>
            </a:r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37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2510B6DB-1AFE-417C-A4D8-76F19E94AD07}"/>
              </a:ext>
            </a:extLst>
          </p:cNvPr>
          <p:cNvSpPr txBox="1"/>
          <p:nvPr/>
        </p:nvSpPr>
        <p:spPr>
          <a:xfrm>
            <a:off x="7140425" y="1072876"/>
            <a:ext cx="32239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PERK                  125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FEC7760D-519A-4C07-B0B7-CADFD15009BF}"/>
              </a:ext>
            </a:extLst>
          </p:cNvPr>
          <p:cNvSpPr txBox="1"/>
          <p:nvPr/>
        </p:nvSpPr>
        <p:spPr>
          <a:xfrm>
            <a:off x="7109340" y="1454008"/>
            <a:ext cx="32514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ATF6</a:t>
            </a:r>
            <a:r>
              <a:rPr lang="es-MX" sz="2000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s-MX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90 </a:t>
            </a:r>
            <a:r>
              <a:rPr lang="es-MX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52653908-6434-47C5-807D-9EC7DAAC198A}"/>
              </a:ext>
            </a:extLst>
          </p:cNvPr>
          <p:cNvSpPr txBox="1"/>
          <p:nvPr/>
        </p:nvSpPr>
        <p:spPr>
          <a:xfrm>
            <a:off x="4319343" y="574118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>
                <a:latin typeface="Arial" panose="020B0604020202020204" pitchFamily="34" charset="0"/>
                <a:cs typeface="Arial" panose="020B0604020202020204" pitchFamily="34" charset="0"/>
              </a:rPr>
              <a:t>Euthyroid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9D0874D3-D411-40DA-AF5B-2A9744D5C66C}"/>
              </a:ext>
            </a:extLst>
          </p:cNvPr>
          <p:cNvSpPr txBox="1"/>
          <p:nvPr/>
        </p:nvSpPr>
        <p:spPr>
          <a:xfrm>
            <a:off x="5660575" y="577751"/>
            <a:ext cx="13917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ypothyroid</a:t>
            </a:r>
            <a:endParaRPr lang="es-MX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Imagen 33">
            <a:extLst>
              <a:ext uri="{FF2B5EF4-FFF2-40B4-BE49-F238E27FC236}">
                <a16:creationId xmlns:a16="http://schemas.microsoft.com/office/drawing/2014/main" id="{DB6CE462-75EC-43D5-9733-77BFB594F3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50" t="31020" r="1102" b="-4479"/>
          <a:stretch/>
        </p:blipFill>
        <p:spPr>
          <a:xfrm>
            <a:off x="1318050" y="3725066"/>
            <a:ext cx="5705225" cy="293915"/>
          </a:xfrm>
          <a:prstGeom prst="rect">
            <a:avLst/>
          </a:prstGeom>
        </p:spPr>
      </p:pic>
      <p:pic>
        <p:nvPicPr>
          <p:cNvPr id="35" name="Imagen 34">
            <a:extLst>
              <a:ext uri="{FF2B5EF4-FFF2-40B4-BE49-F238E27FC236}">
                <a16:creationId xmlns:a16="http://schemas.microsoft.com/office/drawing/2014/main" id="{3EE22A25-641C-420F-BD2D-49023C8BACD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3" t="942" r="-1043" b="59350"/>
          <a:stretch/>
        </p:blipFill>
        <p:spPr>
          <a:xfrm>
            <a:off x="1373560" y="2240914"/>
            <a:ext cx="5746884" cy="275999"/>
          </a:xfrm>
          <a:prstGeom prst="rect">
            <a:avLst/>
          </a:prstGeom>
        </p:spPr>
      </p:pic>
      <p:pic>
        <p:nvPicPr>
          <p:cNvPr id="36" name="Imagen 3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344D79D7-7F06-4DEE-A705-B9D32A08EAB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453"/>
          <a:stretch/>
        </p:blipFill>
        <p:spPr>
          <a:xfrm>
            <a:off x="1350848" y="3360947"/>
            <a:ext cx="5705224" cy="275999"/>
          </a:xfrm>
          <a:prstGeom prst="rect">
            <a:avLst/>
          </a:prstGeom>
        </p:spPr>
      </p:pic>
      <p:pic>
        <p:nvPicPr>
          <p:cNvPr id="37" name="Imagen 36">
            <a:extLst>
              <a:ext uri="{FF2B5EF4-FFF2-40B4-BE49-F238E27FC236}">
                <a16:creationId xmlns:a16="http://schemas.microsoft.com/office/drawing/2014/main" id="{BDB23BF9-D784-4EEC-AF4C-A36708460F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68"/>
          <a:stretch/>
        </p:blipFill>
        <p:spPr>
          <a:xfrm>
            <a:off x="1347077" y="1479080"/>
            <a:ext cx="5705225" cy="275999"/>
          </a:xfrm>
          <a:prstGeom prst="rect">
            <a:avLst/>
          </a:prstGeom>
        </p:spPr>
      </p:pic>
      <p:pic>
        <p:nvPicPr>
          <p:cNvPr id="40" name="Imagen 39">
            <a:extLst>
              <a:ext uri="{FF2B5EF4-FFF2-40B4-BE49-F238E27FC236}">
                <a16:creationId xmlns:a16="http://schemas.microsoft.com/office/drawing/2014/main" id="{8B134DFC-9F2F-4465-922C-AE5FE75D5F3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4539"/>
          <a:stretch/>
        </p:blipFill>
        <p:spPr>
          <a:xfrm>
            <a:off x="1332563" y="1851823"/>
            <a:ext cx="5705225" cy="275999"/>
          </a:xfrm>
          <a:prstGeom prst="rect">
            <a:avLst/>
          </a:prstGeom>
        </p:spPr>
      </p:pic>
      <p:pic>
        <p:nvPicPr>
          <p:cNvPr id="41" name="Imagen 40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49ACE44-D71D-4D64-AAEC-6D970C35E1B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27" b="40984"/>
          <a:stretch/>
        </p:blipFill>
        <p:spPr>
          <a:xfrm>
            <a:off x="1334909" y="3047553"/>
            <a:ext cx="5693189" cy="196287"/>
          </a:xfrm>
          <a:prstGeom prst="rect">
            <a:avLst/>
          </a:prstGeom>
        </p:spPr>
      </p:pic>
      <p:pic>
        <p:nvPicPr>
          <p:cNvPr id="42" name="Imagen 41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8B393A62-2F49-4008-A537-02B0F897F2C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" t="3951" r="-795" b="57085"/>
          <a:stretch/>
        </p:blipFill>
        <p:spPr>
          <a:xfrm>
            <a:off x="1323330" y="2659446"/>
            <a:ext cx="5760455" cy="279651"/>
          </a:xfrm>
          <a:prstGeom prst="rect">
            <a:avLst/>
          </a:prstGeom>
        </p:spPr>
      </p:pic>
      <p:pic>
        <p:nvPicPr>
          <p:cNvPr id="48" name="Imagen 47">
            <a:extLst>
              <a:ext uri="{FF2B5EF4-FFF2-40B4-BE49-F238E27FC236}">
                <a16:creationId xmlns:a16="http://schemas.microsoft.com/office/drawing/2014/main" id="{19EA1651-9D51-45FA-BAA9-1EF9D8C4F3E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045" y="1087602"/>
            <a:ext cx="5688555" cy="338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49092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5</TotalTime>
  <Words>64</Words>
  <Application>Microsoft Office PowerPoint</Application>
  <PresentationFormat>Panorámica</PresentationFormat>
  <Paragraphs>27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dgar CE</dc:creator>
  <cp:lastModifiedBy>Edgar CE</cp:lastModifiedBy>
  <cp:revision>40</cp:revision>
  <dcterms:created xsi:type="dcterms:W3CDTF">2021-01-22T17:34:00Z</dcterms:created>
  <dcterms:modified xsi:type="dcterms:W3CDTF">2021-05-26T18:30:19Z</dcterms:modified>
</cp:coreProperties>
</file>